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27FFF"/>
    <a:srgbClr val="FF0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92" d="100"/>
          <a:sy n="92" d="100"/>
        </p:scale>
        <p:origin x="6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2842"/>
            <a:ext cx="1036320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26842"/>
            <a:ext cx="9144000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8070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6015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79142"/>
            <a:ext cx="2628900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79142"/>
            <a:ext cx="77343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5822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832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3638"/>
            <a:ext cx="1051560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22610"/>
            <a:ext cx="1051560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7587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95710"/>
            <a:ext cx="51816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95710"/>
            <a:ext cx="51816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4416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79144"/>
            <a:ext cx="105156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06137"/>
            <a:ext cx="5157787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87331"/>
            <a:ext cx="5157787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06137"/>
            <a:ext cx="518318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87331"/>
            <a:ext cx="518318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7566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6941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4529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5769"/>
            <a:ext cx="6172200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231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5769"/>
            <a:ext cx="6172200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2099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79144"/>
            <a:ext cx="105156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95710"/>
            <a:ext cx="105156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6C3E0C-8251-482E-A769-DEAB27424116}" type="datetimeFigureOut">
              <a:rPr lang="zh-CN" altLang="en-US" smtClean="0"/>
              <a:t>2020/10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41240"/>
            <a:ext cx="41148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7277B-C8E2-4044-9D34-A6B9647B21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17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3C6CD36A-4C0D-4CBA-8F94-BF3EAF54F9B0}"/>
              </a:ext>
            </a:extLst>
          </p:cNvPr>
          <p:cNvGrpSpPr/>
          <p:nvPr/>
        </p:nvGrpSpPr>
        <p:grpSpPr>
          <a:xfrm>
            <a:off x="1952006" y="857712"/>
            <a:ext cx="7872676" cy="7481332"/>
            <a:chOff x="1842824" y="-254000"/>
            <a:chExt cx="7872676" cy="7481332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804E1D94-96AC-4132-9127-1596B0F2D763}"/>
                </a:ext>
              </a:extLst>
            </p:cNvPr>
            <p:cNvGrpSpPr/>
            <p:nvPr/>
          </p:nvGrpSpPr>
          <p:grpSpPr>
            <a:xfrm>
              <a:off x="2959100" y="-254000"/>
              <a:ext cx="6756400" cy="6982604"/>
              <a:chOff x="2768600" y="0"/>
              <a:chExt cx="6756400" cy="6982604"/>
            </a:xfrm>
          </p:grpSpPr>
          <p:pic>
            <p:nvPicPr>
              <p:cNvPr id="22" name="图片 21" descr="图片包含 地图, 雨, 大, 游戏机&#10;&#10;描述已自动生成">
                <a:extLst>
                  <a:ext uri="{FF2B5EF4-FFF2-40B4-BE49-F238E27FC236}">
                    <a16:creationId xmlns:a16="http://schemas.microsoft.com/office/drawing/2014/main" id="{12AE1F07-3B3A-4AEB-9914-48336F50BC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82" b="2222"/>
              <a:stretch/>
            </p:blipFill>
            <p:spPr>
              <a:xfrm>
                <a:off x="2768600" y="0"/>
                <a:ext cx="6756400" cy="6705600"/>
              </a:xfrm>
              <a:prstGeom prst="rect">
                <a:avLst/>
              </a:prstGeom>
            </p:spPr>
          </p:pic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FB4FB764-E091-4C35-8AD4-BF9BEE6E0D0C}"/>
                  </a:ext>
                </a:extLst>
              </p:cNvPr>
              <p:cNvSpPr txBox="1"/>
              <p:nvPr/>
            </p:nvSpPr>
            <p:spPr>
              <a:xfrm>
                <a:off x="3157865" y="6705605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i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4E87A843-72ED-4E79-91F5-77799C5A755E}"/>
                  </a:ext>
                </a:extLst>
              </p:cNvPr>
              <p:cNvSpPr txBox="1"/>
              <p:nvPr/>
            </p:nvSpPr>
            <p:spPr>
              <a:xfrm>
                <a:off x="4278040" y="6705595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i2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4D7530B5-6E03-49D7-AFD1-6581FD495EDD}"/>
                  </a:ext>
                </a:extLst>
              </p:cNvPr>
              <p:cNvSpPr txBox="1"/>
              <p:nvPr/>
            </p:nvSpPr>
            <p:spPr>
              <a:xfrm>
                <a:off x="5158339" y="6705596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i3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F8DACD98-3A67-4A0E-B4FC-68CDF4420B40}"/>
                  </a:ext>
                </a:extLst>
              </p:cNvPr>
              <p:cNvSpPr txBox="1"/>
              <p:nvPr/>
            </p:nvSpPr>
            <p:spPr>
              <a:xfrm>
                <a:off x="5895888" y="6705597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i4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BF62BA50-92E0-4FFC-A5F4-5684F40F9529}"/>
                  </a:ext>
                </a:extLst>
              </p:cNvPr>
              <p:cNvSpPr txBox="1"/>
              <p:nvPr/>
            </p:nvSpPr>
            <p:spPr>
              <a:xfrm>
                <a:off x="6574362" y="6705598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i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0455EDE5-9978-40AD-B1ED-26A7C9B9DB88}"/>
                  </a:ext>
                </a:extLst>
              </p:cNvPr>
              <p:cNvSpPr txBox="1"/>
              <p:nvPr/>
            </p:nvSpPr>
            <p:spPr>
              <a:xfrm>
                <a:off x="7150270" y="6705598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i6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AE428C19-0501-442E-A06B-D90FFBB54398}"/>
                  </a:ext>
                </a:extLst>
              </p:cNvPr>
              <p:cNvSpPr txBox="1"/>
              <p:nvPr/>
            </p:nvSpPr>
            <p:spPr>
              <a:xfrm>
                <a:off x="7700189" y="6705598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i7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81A15EB9-F8B9-4DB9-8A01-ABF31BD9DA18}"/>
                  </a:ext>
                </a:extLst>
              </p:cNvPr>
              <p:cNvSpPr txBox="1"/>
              <p:nvPr/>
            </p:nvSpPr>
            <p:spPr>
              <a:xfrm>
                <a:off x="8235913" y="6705599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i8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64490861-DD98-49EE-B910-2BD3F3C7570C}"/>
                  </a:ext>
                </a:extLst>
              </p:cNvPr>
              <p:cNvSpPr txBox="1"/>
              <p:nvPr/>
            </p:nvSpPr>
            <p:spPr>
              <a:xfrm>
                <a:off x="8866201" y="6705600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i9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CB262D46-174D-46E1-8B08-592CB704D803}"/>
                </a:ext>
              </a:extLst>
            </p:cNvPr>
            <p:cNvGrpSpPr/>
            <p:nvPr/>
          </p:nvGrpSpPr>
          <p:grpSpPr>
            <a:xfrm>
              <a:off x="2308054" y="-138500"/>
              <a:ext cx="690078" cy="6302958"/>
              <a:chOff x="2308054" y="-138500"/>
              <a:chExt cx="690078" cy="6302958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4C0FABB3-D1D5-47C5-8450-9D56A5C84C67}"/>
                  </a:ext>
                </a:extLst>
              </p:cNvPr>
              <p:cNvSpPr txBox="1"/>
              <p:nvPr/>
            </p:nvSpPr>
            <p:spPr>
              <a:xfrm>
                <a:off x="2313760" y="2737920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BD7043A4-B571-4F02-88F5-B6D9105D845A}"/>
                  </a:ext>
                </a:extLst>
              </p:cNvPr>
              <p:cNvSpPr txBox="1"/>
              <p:nvPr/>
            </p:nvSpPr>
            <p:spPr>
              <a:xfrm>
                <a:off x="2313761" y="1017038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2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6FACE80D-E895-41BF-9B80-A7AD1D8933EE}"/>
                  </a:ext>
                </a:extLst>
              </p:cNvPr>
              <p:cNvSpPr txBox="1"/>
              <p:nvPr/>
            </p:nvSpPr>
            <p:spPr>
              <a:xfrm>
                <a:off x="2313759" y="3590748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3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06793A83-6298-4AB6-B657-690B91ED90F2}"/>
                  </a:ext>
                </a:extLst>
              </p:cNvPr>
              <p:cNvSpPr txBox="1"/>
              <p:nvPr/>
            </p:nvSpPr>
            <p:spPr>
              <a:xfrm>
                <a:off x="2308054" y="5887459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4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0472AD46-EF59-4B08-9192-A59205E43A7C}"/>
                  </a:ext>
                </a:extLst>
              </p:cNvPr>
              <p:cNvSpPr txBox="1"/>
              <p:nvPr/>
            </p:nvSpPr>
            <p:spPr>
              <a:xfrm>
                <a:off x="2319742" y="354792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55D55FFA-40F8-4959-8544-0A20B549A389}"/>
                  </a:ext>
                </a:extLst>
              </p:cNvPr>
              <p:cNvSpPr txBox="1"/>
              <p:nvPr/>
            </p:nvSpPr>
            <p:spPr>
              <a:xfrm>
                <a:off x="2313760" y="1540784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6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5523BA70-0C26-4AF3-B91F-8AF447D6FDFF}"/>
                  </a:ext>
                </a:extLst>
              </p:cNvPr>
              <p:cNvSpPr txBox="1"/>
              <p:nvPr/>
            </p:nvSpPr>
            <p:spPr>
              <a:xfrm>
                <a:off x="2313758" y="5220954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7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027B9B99-1BF4-4545-A9F8-306D6531F4A9}"/>
                  </a:ext>
                </a:extLst>
              </p:cNvPr>
              <p:cNvSpPr txBox="1"/>
              <p:nvPr/>
            </p:nvSpPr>
            <p:spPr>
              <a:xfrm>
                <a:off x="2313761" y="-138500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8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36B58CE3-9FA7-4E53-AB9B-DDD327E6A477}"/>
                  </a:ext>
                </a:extLst>
              </p:cNvPr>
              <p:cNvSpPr txBox="1"/>
              <p:nvPr/>
            </p:nvSpPr>
            <p:spPr>
              <a:xfrm>
                <a:off x="2313758" y="4166577"/>
                <a:ext cx="5934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9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9E910234-E92E-4F13-B630-E5DFFF333CB6}"/>
                  </a:ext>
                </a:extLst>
              </p:cNvPr>
              <p:cNvSpPr txBox="1"/>
              <p:nvPr/>
            </p:nvSpPr>
            <p:spPr>
              <a:xfrm>
                <a:off x="2308054" y="4787884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1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95991B26-E408-42D7-A71B-5D7F5B23677A}"/>
                  </a:ext>
                </a:extLst>
              </p:cNvPr>
              <p:cNvSpPr txBox="1"/>
              <p:nvPr/>
            </p:nvSpPr>
            <p:spPr>
              <a:xfrm>
                <a:off x="2313760" y="2301521"/>
                <a:ext cx="6669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1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F221C076-AACE-4F2F-9AD4-09FE91849D17}"/>
                  </a:ext>
                </a:extLst>
              </p:cNvPr>
              <p:cNvSpPr txBox="1"/>
              <p:nvPr/>
            </p:nvSpPr>
            <p:spPr>
              <a:xfrm>
                <a:off x="2319741" y="1946729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12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1F3A81D4-3529-46D9-856F-F682AE9DEC9D}"/>
                  </a:ext>
                </a:extLst>
              </p:cNvPr>
              <p:cNvSpPr txBox="1"/>
              <p:nvPr/>
            </p:nvSpPr>
            <p:spPr>
              <a:xfrm>
                <a:off x="2313760" y="3163009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bar13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65AF1D4D-64B9-4CBA-91A6-1237846594D0}"/>
                </a:ext>
              </a:extLst>
            </p:cNvPr>
            <p:cNvSpPr/>
            <p:nvPr/>
          </p:nvSpPr>
          <p:spPr>
            <a:xfrm>
              <a:off x="4219294" y="6858000"/>
              <a:ext cx="312136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S. baicalensis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zh-CN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44A0BF6A-B267-475C-95F4-89ABF56F8FAC}"/>
                </a:ext>
              </a:extLst>
            </p:cNvPr>
            <p:cNvSpPr/>
            <p:nvPr/>
          </p:nvSpPr>
          <p:spPr>
            <a:xfrm rot="16200000">
              <a:off x="614282" y="2763749"/>
              <a:ext cx="282641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S. </a:t>
              </a:r>
              <a:r>
                <a:rPr lang="en-US" altLang="zh-CN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ta</a:t>
              </a:r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zh-CN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椭圆 1">
            <a:extLst>
              <a:ext uri="{FF2B5EF4-FFF2-40B4-BE49-F238E27FC236}">
                <a16:creationId xmlns:a16="http://schemas.microsoft.com/office/drawing/2014/main" id="{F744BAB4-39D5-B54E-B5D6-59036C836F3D}"/>
              </a:ext>
            </a:extLst>
          </p:cNvPr>
          <p:cNvSpPr/>
          <p:nvPr/>
        </p:nvSpPr>
        <p:spPr>
          <a:xfrm>
            <a:off x="10072254" y="1410047"/>
            <a:ext cx="108000" cy="108000"/>
          </a:xfrm>
          <a:prstGeom prst="ellipse">
            <a:avLst/>
          </a:prstGeom>
          <a:solidFill>
            <a:srgbClr val="FF0300"/>
          </a:solidFill>
          <a:ln>
            <a:solidFill>
              <a:srgbClr val="FF0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sp>
        <p:nvSpPr>
          <p:cNvPr id="32" name="椭圆 31">
            <a:extLst>
              <a:ext uri="{FF2B5EF4-FFF2-40B4-BE49-F238E27FC236}">
                <a16:creationId xmlns:a16="http://schemas.microsoft.com/office/drawing/2014/main" id="{1460F238-D843-C64D-9BFB-8D6915E57FAA}"/>
              </a:ext>
            </a:extLst>
          </p:cNvPr>
          <p:cNvSpPr/>
          <p:nvPr/>
        </p:nvSpPr>
        <p:spPr>
          <a:xfrm>
            <a:off x="10072253" y="1700996"/>
            <a:ext cx="108000" cy="108000"/>
          </a:xfrm>
          <a:prstGeom prst="ellipse">
            <a:avLst/>
          </a:prstGeom>
          <a:solidFill>
            <a:srgbClr val="027FFF"/>
          </a:solidFill>
          <a:ln>
            <a:solidFill>
              <a:srgbClr val="027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B69506F6-C8EF-6A49-9093-BC3AF37FA578}"/>
              </a:ext>
            </a:extLst>
          </p:cNvPr>
          <p:cNvSpPr/>
          <p:nvPr/>
        </p:nvSpPr>
        <p:spPr>
          <a:xfrm>
            <a:off x="10197549" y="1281838"/>
            <a:ext cx="17235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orward matc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69BB70B0-4455-354E-B577-3FB380393350}"/>
              </a:ext>
            </a:extLst>
          </p:cNvPr>
          <p:cNvSpPr/>
          <p:nvPr/>
        </p:nvSpPr>
        <p:spPr>
          <a:xfrm>
            <a:off x="10197549" y="1558837"/>
            <a:ext cx="17363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everse matc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4645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34</Words>
  <Application>Microsoft Macintosh PowerPoint</Application>
  <PresentationFormat>自定义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Zhichao Xu</cp:lastModifiedBy>
  <cp:revision>2</cp:revision>
  <dcterms:created xsi:type="dcterms:W3CDTF">2020-02-20T13:05:47Z</dcterms:created>
  <dcterms:modified xsi:type="dcterms:W3CDTF">2020-10-23T06:03:33Z</dcterms:modified>
</cp:coreProperties>
</file>